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DEB793B-9795-4BB9-B1C2-CDEB9952E7F2}">
          <p14:sldIdLst>
            <p14:sldId id="257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350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ig_chngecorrelation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2" t="12149" r="5411" b="6813"/>
          <a:stretch>
            <a:fillRect/>
          </a:stretch>
        </p:blipFill>
        <p:spPr bwMode="auto">
          <a:xfrm>
            <a:off x="838200" y="609601"/>
            <a:ext cx="4972050" cy="4295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228600" y="5181601"/>
            <a:ext cx="6400800" cy="184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/>
              <a:t>Electronic Supplementary Material 2 Correlation between change values of clinical risk factors and modelled risk from diagnosis to 5 years in </a:t>
            </a:r>
            <a:r>
              <a:rPr lang="pt-PT" sz="1400" b="1" i="1" dirty="0"/>
              <a:t>ADDITION-Europe </a:t>
            </a:r>
            <a:r>
              <a:rPr lang="pt-PT" sz="1400" b="1" dirty="0"/>
              <a:t>(both treatment groups combined). Scatter graphs (lower diagonal) and loess smoothed curves with bivariate 68% concentration ellipses (upper diagonal) of the absolute change of each variable are plotted. Maximum and minimum change are listed beside each label. </a:t>
            </a:r>
            <a:r>
              <a:rPr lang="pt-PT" sz="1400" b="1" baseline="30000" dirty="0"/>
              <a:t>a</a:t>
            </a:r>
            <a:r>
              <a:rPr lang="pt-PT" sz="1400" b="1" dirty="0"/>
              <a:t>UKPDS modelled 10-year CVD risk. </a:t>
            </a:r>
            <a:r>
              <a:rPr lang="pt-PT" sz="1400" b="1" baseline="30000" dirty="0"/>
              <a:t>b</a:t>
            </a:r>
            <a:r>
              <a:rPr lang="pt-PT" sz="1400" b="1" dirty="0"/>
              <a:t>Systolic blood pressure. </a:t>
            </a:r>
            <a:r>
              <a:rPr lang="pt-PT" sz="1400" b="1" baseline="30000" dirty="0"/>
              <a:t>c</a:t>
            </a:r>
            <a:r>
              <a:rPr lang="pt-PT" sz="1400" b="1" dirty="0"/>
              <a:t>Cholesterol ratio. </a:t>
            </a:r>
            <a:r>
              <a:rPr lang="pt-PT" sz="1400" b="1" baseline="30000" dirty="0"/>
              <a:t>d</a:t>
            </a:r>
            <a:r>
              <a:rPr lang="pt-PT" sz="1400" b="1" dirty="0"/>
              <a:t>Triglycerides. </a:t>
            </a:r>
            <a:r>
              <a:rPr lang="pt-PT" sz="1400" b="1" baseline="30000" dirty="0"/>
              <a:t>e</a:t>
            </a:r>
            <a:r>
              <a:rPr lang="pt-PT" sz="1400" b="1" dirty="0"/>
              <a:t>Time between diagnosis and 5 year follow up. NOTE: ACR is dichotomisedinto two binary variables in the UKPDS model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193644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Black</dc:creator>
  <cp:lastModifiedBy>James Black</cp:lastModifiedBy>
  <cp:revision>4</cp:revision>
  <dcterms:created xsi:type="dcterms:W3CDTF">2006-08-16T00:00:00Z</dcterms:created>
  <dcterms:modified xsi:type="dcterms:W3CDTF">2013-09-25T11:39:26Z</dcterms:modified>
</cp:coreProperties>
</file>